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21" d="100"/>
          <a:sy n="121" d="100"/>
        </p:scale>
        <p:origin x="-1308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304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0812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30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555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463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609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607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045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3729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739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317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18A31-86F8-4587-9722-89EAEEF5E5EE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EA3A0-04B9-4D52-AEE7-1E79499671F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348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025" y="133350"/>
            <a:ext cx="4762500" cy="65627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553076" y="133350"/>
            <a:ext cx="359092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3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ce (blue) / absence (yellow)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splaying only the gene families found to be significantly over- (or under-) represented in genomes deriving from one of the four sampling sites.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727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0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posito, Alfonso</dc:creator>
  <cp:lastModifiedBy>Olivier Jousson</cp:lastModifiedBy>
  <cp:revision>4</cp:revision>
  <dcterms:created xsi:type="dcterms:W3CDTF">2018-06-20T12:08:12Z</dcterms:created>
  <dcterms:modified xsi:type="dcterms:W3CDTF">2018-09-14T12:45:16Z</dcterms:modified>
</cp:coreProperties>
</file>